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4E4B5-0827-436C-A646-F5E8F0DBC6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CB48B-D6DD-4D4A-AD30-B0B7AAA98E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BC0DC-191B-4556-A77A-40A5174F4A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96CD7-93B1-45CA-A700-13628AE4E6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76076-76BA-49D3-B8D0-836F891C6C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F0007-8C68-424E-815F-C03A58C575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43BA4-7BF8-4F4A-BAE0-7B8E09DCC6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1240D-DCCE-4B59-9F00-B868A5050B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4B60B-49D6-4D1D-9B34-78785CEA8F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42D5B-F39F-4E6F-BF74-1EA03CE539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4BBF7-CC81-424A-882B-533D2FE791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4790D-EADC-41B3-9CBB-A535CBD1FB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b-NO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53DFD2-902E-4AE7-B757-A0B64DE2C413}" type="slidenum">
              <a:rPr b="0" lang="nb-NO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MMR_1.png"/>
          <p:cNvPicPr/>
          <p:nvPr/>
        </p:nvPicPr>
        <p:blipFill>
          <a:blip r:embed="rId1"/>
          <a:stretch/>
        </p:blipFill>
        <p:spPr>
          <a:xfrm>
            <a:off x="395280" y="44280"/>
            <a:ext cx="8748720" cy="576108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3"/>
          <p:cNvSpPr/>
          <p:nvPr/>
        </p:nvSpPr>
        <p:spPr>
          <a:xfrm>
            <a:off x="468360" y="5999400"/>
            <a:ext cx="8280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MSH: mutS homolog 2, colon cancer, nonpolyposis type 1 (E. coli) alias: DNA mismatch repair protein Msh2, MutSbeta: MutSbeta complex plays a role in mismatch repair. It consists of MSH2 and MSH3 subunits, PMS: postmeiotic segregation increased 1/ DNA mismatch repair protein PMS1, EXO1: exonuclease 1, RPA1: replication protein A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15T11:15:19Z</dcterms:created>
  <dc:creator>Siv Kjølsrud Bøhn</dc:creator>
  <dc:description/>
  <dc:language>en-US</dc:language>
  <cp:lastModifiedBy>Siv Kjølsrud Bøhn</cp:lastModifiedBy>
  <dcterms:modified xsi:type="dcterms:W3CDTF">2010-07-16T10:27:22Z</dcterms:modified>
  <cp:revision>2</cp:revision>
  <dc:subject/>
  <dc:title>Slide 1</dc:title>
</cp:coreProperties>
</file>